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4094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417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497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517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929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253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7510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09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921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509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8813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8C4F8-0DD3-4EC1-89A9-1C29282C65E6}" type="datetimeFigureOut">
              <a:rPr lang="en-US" smtClean="0"/>
              <a:t>8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7D8616-E1DB-49CF-8CCF-8642A836B3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3605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98143" y="741872"/>
            <a:ext cx="73842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/>
              <a:t>README </a:t>
            </a:r>
            <a:r>
              <a:rPr lang="en-US" dirty="0"/>
              <a:t>- Fig 1R V116M A688V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906436" y="1620163"/>
            <a:ext cx="8402126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en-US" dirty="0" smtClean="0"/>
              <a:t>Perform a blind analysis of gephyrin and spine density and size from 16 </a:t>
            </a:r>
            <a:r>
              <a:rPr lang="en-US" dirty="0"/>
              <a:t>V116M </a:t>
            </a:r>
            <a:r>
              <a:rPr lang="en-US" dirty="0" smtClean="0"/>
              <a:t>A688V cells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Randomly select a subset of cells whose gephyrin and spine measurements are closest to the group average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From the selected cells, identify one ROI (dendritic segment) that is free of overlapping dendrites above or below the targeted region.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 smtClean="0"/>
              <a:t>Crop the image at the center of the selected ROI to ensure clear visualization of gephyrin and spines. </a:t>
            </a:r>
          </a:p>
          <a:p>
            <a:pPr marL="342900" indent="-342900">
              <a:buAutoNum type="arabicPeriod"/>
            </a:pPr>
            <a:endParaRPr lang="en-US" dirty="0" smtClean="0"/>
          </a:p>
          <a:p>
            <a:pPr marL="342900" indent="-342900">
              <a:buAutoNum type="arabicPeriod"/>
            </a:pPr>
            <a:r>
              <a:rPr lang="en-US" dirty="0"/>
              <a:t>Generate a dual-color two-photon image stack (512 × 512 pixels, 0.047 µm/pixel resolution, 1 µm z-steps</a:t>
            </a:r>
            <a:r>
              <a:rPr lang="en-US" dirty="0" smtClean="0"/>
              <a:t>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2370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05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U Denver | Anschutz Medical Camp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n Chan Oh</dc:creator>
  <cp:lastModifiedBy>Won Chan Oh</cp:lastModifiedBy>
  <cp:revision>3</cp:revision>
  <dcterms:created xsi:type="dcterms:W3CDTF">2025-08-11T17:05:23Z</dcterms:created>
  <dcterms:modified xsi:type="dcterms:W3CDTF">2025-08-11T17:36:37Z</dcterms:modified>
</cp:coreProperties>
</file>